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  <p:sldId id="272" r:id="rId3"/>
    <p:sldId id="273" r:id="rId4"/>
    <p:sldId id="274" r:id="rId5"/>
    <p:sldId id="275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Hyperopia" id="{0969E8EA-A673-AA43-B389-AD02B16A0247}">
          <p14:sldIdLst>
            <p14:sldId id="269"/>
            <p14:sldId id="272"/>
            <p14:sldId id="273"/>
            <p14:sldId id="274"/>
            <p14:sldId id="275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  <p15:guide id="3" pos="5019" userDrawn="1">
          <p15:clr>
            <a:srgbClr val="A4A3A4"/>
          </p15:clr>
        </p15:guide>
        <p15:guide id="4" pos="75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81" d="100"/>
          <a:sy n="81" d="100"/>
        </p:scale>
        <p:origin x="84" y="140"/>
      </p:cViewPr>
      <p:guideLst>
        <p:guide orient="horz" pos="2160"/>
        <p:guide pos="3840"/>
        <p:guide pos="5019"/>
        <p:guide pos="75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900113" cy="900113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5115A6-4AD4-42C2-4558-C80641B09D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DFA6F3F-F858-9879-8BE4-E0D2D45E06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78BAE4-74AC-9F74-1026-BF566794E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6FA97C-7A6B-5235-F1FB-866A759D8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02186A-75A5-6F4A-E499-98BC3D76D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8109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C54DE0-A18A-BF8A-02A3-8D6F1A0B94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2BCB0E-2C33-66CA-0174-B91029E993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D76706-106D-EA51-B34F-59391B5FE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4F882B-02E0-85DD-EA6A-21D35A0CE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FF7E62-D854-BE45-7A7D-F91E563164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9640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DF5FF0F-3F3B-B08B-8517-959A144CAA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0AC674-014A-547B-5753-A0B4127DE6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CBCFE7-C0F6-44C0-B075-EFDE65EB0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C77597-63E2-B765-1A3F-91039CC8A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420617-1E41-881D-11FC-52B65BCA3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7223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0C82DF-85E8-A1FF-721D-0F91B4B83A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781788-E569-2976-2ECC-AB4218236F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BB242-24E9-DDA6-80BD-20D416D2E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E27C1D-8CDC-F1B4-326D-E15E7C42F4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AEABEB-681D-02C7-F6B9-5DD162809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1597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FE92BF-696B-F288-1E62-BCFDE6CF3F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199255-F495-E8AA-794D-1B19220C44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4175A0-1791-9C3F-92E5-4A6D5AB07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91A432-AA20-CA8E-7B6C-A5CDF9417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D7517A-2212-A5C1-F185-E37E6D038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5655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81902D-4608-F418-5B0D-BD32D80E2F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324721-5A1E-ADEA-7F8E-611FF81D9B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EB8D5A-D9A8-2141-D7AB-3A2CDC8247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B19C3A-0244-C9EE-9933-C263F1CBB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B7AD71-7CF4-B577-6428-D3B2409BB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207ABC-0002-E1EF-F82D-67A9EEC5F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9520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6043C6-EF55-C9A1-341D-922902644A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016A87-01D9-58AB-EBEE-55490AFB3A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027A6C-6A48-5A29-37ED-AE7B353C2C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C7BED5B-5D44-D730-D881-7A3387C18C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FA138AF-1C79-1385-7450-B634F87B54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C5241ED-4A92-916B-8AA9-D0D836F33D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4B2203-EE3F-2801-FA5B-3383155F4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49E334-604E-9220-3C71-F5B120C37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1068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41CB91-65D8-C601-ACE0-09BD77266C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A199E4E-5CCD-D8A3-41DD-38E74CA63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C21506-9895-23DE-D005-8AB627F462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89ACED2-C1B4-A5FB-7852-9B47D0599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1679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B3B0AB8-8B5E-B917-E7DB-6B6D199B4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F20FEBF-FC09-75D1-CF58-183D8D5129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A5867A6-AC50-7AA0-C633-D54EBBF0C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1559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8CF12B-932B-2DDD-E42D-ABD972DB1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F3E617-12F3-59FE-10EF-9BD43C335F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CFCFC6-46F7-E984-3E2C-A0B8BA616B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5A06F0-9AB4-56BF-F5B6-5015DF5B5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5F4850-2C75-F9D4-D8DC-403CCE73CC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FC9005-F81A-8D78-16AC-95380A412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0984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A94874-71D0-364D-6DDE-702A878ADA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7B6FD7-E7A7-9A07-1233-7B01602633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CF216D-F379-746D-38BB-35266ECE05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DC6530-E729-8FC0-A0E9-20308DAEEC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619B72-0E3B-0B3E-608A-8E593CD5A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3CA04A-4AFE-F5AE-B20A-E75B3B799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4729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C741008-CFDC-B271-ABFD-D59B332B73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B2A9F8-342C-1238-92F6-B35D24595E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EC5298-81BD-4C5D-DD10-7FA4143940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3DE247-8C8A-83C6-19A7-19084BFB0B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C162BF-50A9-DFD6-27D7-7EFD301DB4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9536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929E8F-47BB-A4A6-6FFF-062265817BE4}"/>
              </a:ext>
            </a:extLst>
          </p:cNvPr>
          <p:cNvSpPr txBox="1"/>
          <p:nvPr/>
        </p:nvSpPr>
        <p:spPr>
          <a:xfrm>
            <a:off x="0" y="5765368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s: S4S2 relative frequency distributions showing LE &amp; RE SER data with vertical lines added at -0.5, 0, and 4</a:t>
            </a:r>
          </a:p>
        </p:txBody>
      </p:sp>
      <p:pic>
        <p:nvPicPr>
          <p:cNvPr id="15" name="Picture 14" descr="A graph of two people&#10;&#10;Description automatically generated">
            <a:extLst>
              <a:ext uri="{FF2B5EF4-FFF2-40B4-BE49-F238E27FC236}">
                <a16:creationId xmlns:a16="http://schemas.microsoft.com/office/drawing/2014/main" id="{B556E028-F869-E8A5-C14F-48FA117FDFDE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685368"/>
            <a:ext cx="12192000" cy="5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92540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aph of two people&#10;&#10;Description automatically generated">
            <a:extLst>
              <a:ext uri="{FF2B5EF4-FFF2-40B4-BE49-F238E27FC236}">
                <a16:creationId xmlns:a16="http://schemas.microsoft.com/office/drawing/2014/main" id="{6541CA1F-170A-3755-84D9-3AC586494E29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685368"/>
            <a:ext cx="12192000" cy="5080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140F9E5-837D-2362-B7B7-ED869B511524}"/>
              </a:ext>
            </a:extLst>
          </p:cNvPr>
          <p:cNvSpPr txBox="1"/>
          <p:nvPr/>
        </p:nvSpPr>
        <p:spPr>
          <a:xfrm>
            <a:off x="0" y="5765368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s: S4S2 relative frequency distributions showing LE &amp; RE SER data with vertical lines added at -0.5, 0, and 4</a:t>
            </a:r>
          </a:p>
        </p:txBody>
      </p:sp>
    </p:spTree>
    <p:extLst>
      <p:ext uri="{BB962C8B-B14F-4D97-AF65-F5344CB8AC3E}">
        <p14:creationId xmlns:p14="http://schemas.microsoft.com/office/powerpoint/2010/main" val="11331737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aph of a person and person&#10;&#10;Description automatically generated">
            <a:extLst>
              <a:ext uri="{FF2B5EF4-FFF2-40B4-BE49-F238E27FC236}">
                <a16:creationId xmlns:a16="http://schemas.microsoft.com/office/drawing/2014/main" id="{B7EA7261-C684-E4FF-C817-454904D1DF2E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685368"/>
            <a:ext cx="12192000" cy="5080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66C8C14-A02C-5228-512C-43C32B912812}"/>
              </a:ext>
            </a:extLst>
          </p:cNvPr>
          <p:cNvSpPr txBox="1"/>
          <p:nvPr/>
        </p:nvSpPr>
        <p:spPr>
          <a:xfrm>
            <a:off x="0" y="5765368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s: S4S2 relative frequency distributions showing LE &amp; RE SER data with vertical lines added at -0.5, 0, and 4</a:t>
            </a:r>
          </a:p>
        </p:txBody>
      </p:sp>
    </p:spTree>
    <p:extLst>
      <p:ext uri="{BB962C8B-B14F-4D97-AF65-F5344CB8AC3E}">
        <p14:creationId xmlns:p14="http://schemas.microsoft.com/office/powerpoint/2010/main" val="27396457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aph of a number of people&#10;&#10;Description automatically generated with medium confidence">
            <a:extLst>
              <a:ext uri="{FF2B5EF4-FFF2-40B4-BE49-F238E27FC236}">
                <a16:creationId xmlns:a16="http://schemas.microsoft.com/office/drawing/2014/main" id="{944A059C-E74B-53A9-02D3-3FCA0E20D92E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685368"/>
            <a:ext cx="12192000" cy="5080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3BAC145-6756-54EC-FE47-0C40F813ECC6}"/>
              </a:ext>
            </a:extLst>
          </p:cNvPr>
          <p:cNvSpPr txBox="1"/>
          <p:nvPr/>
        </p:nvSpPr>
        <p:spPr>
          <a:xfrm>
            <a:off x="0" y="5765368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s: S4S2 relative frequency distributions showing LE &amp; RE SER data with vertical lines added at -0.5, 0, and 4</a:t>
            </a:r>
          </a:p>
        </p:txBody>
      </p:sp>
    </p:spTree>
    <p:extLst>
      <p:ext uri="{BB962C8B-B14F-4D97-AF65-F5344CB8AC3E}">
        <p14:creationId xmlns:p14="http://schemas.microsoft.com/office/powerpoint/2010/main" val="1898351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number of people&#10;&#10;Description automatically generated with medium confidence">
            <a:extLst>
              <a:ext uri="{FF2B5EF4-FFF2-40B4-BE49-F238E27FC236}">
                <a16:creationId xmlns:a16="http://schemas.microsoft.com/office/drawing/2014/main" id="{AC219025-2253-5497-A564-51622BBD41C6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685368"/>
            <a:ext cx="12192000" cy="508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31B87D6-691B-6157-6F17-298C989F20FF}"/>
              </a:ext>
            </a:extLst>
          </p:cNvPr>
          <p:cNvSpPr txBox="1"/>
          <p:nvPr/>
        </p:nvSpPr>
        <p:spPr>
          <a:xfrm>
            <a:off x="0" y="5765368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s: S4S2 relative frequency distributions showing LE &amp; RE SER data with vertical lines added at -0.5, 0, and 4</a:t>
            </a:r>
          </a:p>
        </p:txBody>
      </p:sp>
    </p:spTree>
    <p:extLst>
      <p:ext uri="{BB962C8B-B14F-4D97-AF65-F5344CB8AC3E}">
        <p14:creationId xmlns:p14="http://schemas.microsoft.com/office/powerpoint/2010/main" val="40043265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0</TotalTime>
  <Words>120</Words>
  <Application>Microsoft Office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njamin Evans</dc:creator>
  <cp:lastModifiedBy>Mark Rosenfield</cp:lastModifiedBy>
  <cp:revision>2</cp:revision>
  <dcterms:created xsi:type="dcterms:W3CDTF">2024-08-11T16:34:56Z</dcterms:created>
  <dcterms:modified xsi:type="dcterms:W3CDTF">2024-09-25T10:08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06c24981-b6df-48f8-949b-0896357b9b03_Enabled">
    <vt:lpwstr>true</vt:lpwstr>
  </property>
  <property fmtid="{D5CDD505-2E9C-101B-9397-08002B2CF9AE}" pid="3" name="MSIP_Label_06c24981-b6df-48f8-949b-0896357b9b03_SetDate">
    <vt:lpwstr>2024-08-11T16:36:36Z</vt:lpwstr>
  </property>
  <property fmtid="{D5CDD505-2E9C-101B-9397-08002B2CF9AE}" pid="4" name="MSIP_Label_06c24981-b6df-48f8-949b-0896357b9b03_Method">
    <vt:lpwstr>Standard</vt:lpwstr>
  </property>
  <property fmtid="{D5CDD505-2E9C-101B-9397-08002B2CF9AE}" pid="5" name="MSIP_Label_06c24981-b6df-48f8-949b-0896357b9b03_Name">
    <vt:lpwstr>Official</vt:lpwstr>
  </property>
  <property fmtid="{D5CDD505-2E9C-101B-9397-08002B2CF9AE}" pid="6" name="MSIP_Label_06c24981-b6df-48f8-949b-0896357b9b03_SiteId">
    <vt:lpwstr>dd615949-5bd0-4da0-ac52-28ef8d336373</vt:lpwstr>
  </property>
  <property fmtid="{D5CDD505-2E9C-101B-9397-08002B2CF9AE}" pid="7" name="MSIP_Label_06c24981-b6df-48f8-949b-0896357b9b03_ActionId">
    <vt:lpwstr>223edce3-2fbe-4dd7-9532-4fd3c8243481</vt:lpwstr>
  </property>
  <property fmtid="{D5CDD505-2E9C-101B-9397-08002B2CF9AE}" pid="8" name="MSIP_Label_06c24981-b6df-48f8-949b-0896357b9b03_ContentBits">
    <vt:lpwstr>0</vt:lpwstr>
  </property>
</Properties>
</file>